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1" autoAdjust="0"/>
    <p:restoredTop sz="94660"/>
  </p:normalViewPr>
  <p:slideViewPr>
    <p:cSldViewPr snapToGrid="0">
      <p:cViewPr varScale="1">
        <p:scale>
          <a:sx n="45" d="100"/>
          <a:sy n="45" d="100"/>
        </p:scale>
        <p:origin x="24" y="9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638F0-1503-4B66-A03C-6F85F43DF07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B1912-D368-4CE1-A6AB-9F60358789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71894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638F0-1503-4B66-A03C-6F85F43DF07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B1912-D368-4CE1-A6AB-9F60358789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31509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638F0-1503-4B66-A03C-6F85F43DF07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B1912-D368-4CE1-A6AB-9F60358789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8095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638F0-1503-4B66-A03C-6F85F43DF07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B1912-D368-4CE1-A6AB-9F60358789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04306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638F0-1503-4B66-A03C-6F85F43DF07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B1912-D368-4CE1-A6AB-9F60358789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05231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638F0-1503-4B66-A03C-6F85F43DF07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B1912-D368-4CE1-A6AB-9F60358789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4605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638F0-1503-4B66-A03C-6F85F43DF07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B1912-D368-4CE1-A6AB-9F60358789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83987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638F0-1503-4B66-A03C-6F85F43DF07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B1912-D368-4CE1-A6AB-9F60358789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86590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638F0-1503-4B66-A03C-6F85F43DF07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B1912-D368-4CE1-A6AB-9F60358789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7898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638F0-1503-4B66-A03C-6F85F43DF07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B1912-D368-4CE1-A6AB-9F60358789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1188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638F0-1503-4B66-A03C-6F85F43DF07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B1912-D368-4CE1-A6AB-9F60358789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0842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F638F0-1503-4B66-A03C-6F85F43DF07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FB1912-D368-4CE1-A6AB-9F60358789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00074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63579" y="786063"/>
            <a:ext cx="8540967" cy="4644607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1363579" y="5655734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S21.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Correlation between β-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(log(BIHA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)) and 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(log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­)) for biquinolines against sensitive strain W2</a:t>
            </a: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978678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6:16:39Z</dcterms:created>
  <dcterms:modified xsi:type="dcterms:W3CDTF">2020-08-04T16:35:30Z</dcterms:modified>
</cp:coreProperties>
</file>